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948488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D34F9-DC2D-4910-88CE-B94CF86FEF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B0201-6798-4F3A-9D0F-D26D62AB49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05B83-1912-4B56-9151-264E3AA9AC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F9F56-207B-417A-9666-0AF3EC2A81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17AE1-D967-4FD9-98E3-AB78FC851D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57DE2-B24B-4CEC-ABD6-750142D4DB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F44DE-A9EB-48B0-8F2E-97410B3C00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53116-E63D-487D-90AD-4811AB3ADC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915F3-854C-40CE-96A0-4BD0C6DC90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D750C-C400-4228-A9C9-73C21CCBD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73EB9-E03F-4A63-B826-EB33A90C43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CBD51-613F-4259-B394-519379285F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9F3CDC-5925-496D-AFF8-9625CFA576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WT 22wk ANOVA Sal vs Tum IPA Network1"/>
          <p:cNvPicPr/>
          <p:nvPr/>
        </p:nvPicPr>
        <p:blipFill>
          <a:blip r:embed="rId1"/>
          <a:stretch/>
        </p:blipFill>
        <p:spPr>
          <a:xfrm>
            <a:off x="147600" y="990720"/>
            <a:ext cx="3322800" cy="3429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WT 22wk ANOVA Sal vs Tum IPA Network2"/>
          <p:cNvPicPr/>
          <p:nvPr/>
        </p:nvPicPr>
        <p:blipFill>
          <a:blip r:embed="rId2"/>
          <a:stretch/>
        </p:blipFill>
        <p:spPr>
          <a:xfrm>
            <a:off x="3446640" y="990720"/>
            <a:ext cx="3335040" cy="3429000"/>
          </a:xfrm>
          <a:prstGeom prst="rect">
            <a:avLst/>
          </a:prstGeom>
          <a:ln w="0">
            <a:noFill/>
          </a:ln>
        </p:spPr>
      </p:pic>
      <p:sp>
        <p:nvSpPr>
          <p:cNvPr id="43" name="Text Box 6"/>
          <p:cNvSpPr/>
          <p:nvPr/>
        </p:nvSpPr>
        <p:spPr>
          <a:xfrm>
            <a:off x="188640" y="152280"/>
            <a:ext cx="645048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1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op functional networks of fold-changed genes in lung tumor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Nrf2</a:t>
            </a:r>
            <a:r>
              <a:rPr b="1" i="1" lang="en-US" sz="1200" spc="-1" strike="noStrike" baseline="30000">
                <a:solidFill>
                  <a:srgbClr val="000000"/>
                </a:solidFill>
                <a:latin typeface="Arial"/>
              </a:rPr>
              <a:t>+/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mice at 22 wk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1" descr="WT 22wk ANOVA Sal vs Tum IPA Network3"/>
          <p:cNvPicPr/>
          <p:nvPr/>
        </p:nvPicPr>
        <p:blipFill>
          <a:blip r:embed="rId3"/>
          <a:stretch/>
        </p:blipFill>
        <p:spPr>
          <a:xfrm>
            <a:off x="152280" y="4879800"/>
            <a:ext cx="3353040" cy="34261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4" descr="WT 22wk ANOVA Sal vs Tum IPA Network4"/>
          <p:cNvPicPr/>
          <p:nvPr/>
        </p:nvPicPr>
        <p:blipFill>
          <a:blip r:embed="rId4"/>
          <a:stretch/>
        </p:blipFill>
        <p:spPr>
          <a:xfrm>
            <a:off x="3444840" y="4876920"/>
            <a:ext cx="3336840" cy="3429000"/>
          </a:xfrm>
          <a:prstGeom prst="rect">
            <a:avLst/>
          </a:prstGeom>
          <a:ln w="0">
            <a:noFill/>
          </a:ln>
        </p:spPr>
      </p:pic>
      <p:sp>
        <p:nvSpPr>
          <p:cNvPr id="46" name="Text Box 17"/>
          <p:cNvSpPr/>
          <p:nvPr/>
        </p:nvSpPr>
        <p:spPr>
          <a:xfrm>
            <a:off x="-265320" y="685800"/>
            <a:ext cx="3512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. Genetic Disorder, Skeletal and Muscular Disorders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velopmental Disorder (Score 4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8"/>
          <p:cNvSpPr/>
          <p:nvPr/>
        </p:nvSpPr>
        <p:spPr>
          <a:xfrm>
            <a:off x="3008880" y="685800"/>
            <a:ext cx="4058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. Cellular Development, hematological System Development an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unction, Hematopoiesis  (Score 3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9"/>
          <p:cNvSpPr/>
          <p:nvPr/>
        </p:nvSpPr>
        <p:spPr>
          <a:xfrm>
            <a:off x="-193320" y="4572000"/>
            <a:ext cx="3748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. Cellular growth and Proliferation, hematological System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velopment and Function, Hematopoiesis (Score 3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0"/>
          <p:cNvSpPr/>
          <p:nvPr/>
        </p:nvSpPr>
        <p:spPr>
          <a:xfrm>
            <a:off x="3011400" y="4724280"/>
            <a:ext cx="3375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. Cell Cycle, Cellular Movement, Cancer (Score 3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" descr="WT 22wk ANOVA Sal vs Tum IPA Network5"/>
          <p:cNvPicPr/>
          <p:nvPr/>
        </p:nvPicPr>
        <p:blipFill>
          <a:blip r:embed="rId1"/>
          <a:stretch/>
        </p:blipFill>
        <p:spPr>
          <a:xfrm>
            <a:off x="533520" y="914400"/>
            <a:ext cx="3809880" cy="3400560"/>
          </a:xfrm>
          <a:prstGeom prst="rect">
            <a:avLst/>
          </a:prstGeom>
          <a:ln w="0">
            <a:noFill/>
          </a:ln>
        </p:spPr>
      </p:pic>
      <p:sp>
        <p:nvSpPr>
          <p:cNvPr id="51" name="Text Box 5"/>
          <p:cNvSpPr/>
          <p:nvPr/>
        </p:nvSpPr>
        <p:spPr>
          <a:xfrm>
            <a:off x="109440" y="609480"/>
            <a:ext cx="40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. Amino Acid Metabolism, Molecular Transport, Small Molecul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iochemistry (Score 3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2T19:40:40Z</dcterms:created>
  <dc:creator>cho2</dc:creator>
  <dc:description/>
  <dc:language>en-US</dc:language>
  <cp:lastModifiedBy>College of Vet Med</cp:lastModifiedBy>
  <dcterms:modified xsi:type="dcterms:W3CDTF">2011-04-08T02:12:09Z</dcterms:modified>
  <cp:revision>9</cp:revision>
  <dc:subject/>
  <dc:title>Slide 1</dc:title>
</cp:coreProperties>
</file>